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68" r:id="rId2"/>
    <p:sldId id="269" r:id="rId3"/>
    <p:sldId id="258" r:id="rId4"/>
    <p:sldId id="259" r:id="rId5"/>
    <p:sldId id="256" r:id="rId6"/>
    <p:sldId id="267" r:id="rId7"/>
    <p:sldId id="266" r:id="rId8"/>
    <p:sldId id="260" r:id="rId9"/>
    <p:sldId id="261" r:id="rId10"/>
    <p:sldId id="270" r:id="rId11"/>
    <p:sldId id="271" r:id="rId12"/>
    <p:sldId id="272" r:id="rId13"/>
    <p:sldId id="273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38" autoAdjust="0"/>
    <p:restoredTop sz="94579"/>
  </p:normalViewPr>
  <p:slideViewPr>
    <p:cSldViewPr snapToGrid="0" snapToObjects="1">
      <p:cViewPr varScale="1">
        <p:scale>
          <a:sx n="110" d="100"/>
          <a:sy n="110" d="100"/>
        </p:scale>
        <p:origin x="660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9EAA92-D413-4346-9622-42992F9148BB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8AB078-8118-A748-ACC8-1D9BDFDB147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7743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8AB078-8118-A748-ACC8-1D9BDFDB147E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8186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897301">
              <a:defRPr/>
            </a:pP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965638-E03B-472A-B86B-0E73C2451F9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6431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965638-E03B-472A-B86B-0E73C2451F9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2178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8633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7801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62759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00940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8433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682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074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91332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73493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4831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5045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5B32B-15E0-BC47-A3A7-FD37A7414833}" type="datetimeFigureOut">
              <a:rPr kumimoji="1" lang="zh-CN" altLang="en-US" smtClean="0"/>
              <a:t>2017/4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26EB1-6A3C-0241-8E42-0054C9A9A0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3019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1601" y="116926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endParaRPr lang="en-US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1219200" y="1447800"/>
            <a:ext cx="9753600" cy="3849576"/>
            <a:chOff x="990600" y="1676400"/>
            <a:chExt cx="7315200" cy="3849576"/>
          </a:xfrm>
        </p:grpSpPr>
        <p:pic>
          <p:nvPicPr>
            <p:cNvPr id="1027" name="Picture 3" descr="C:\Users\isundar\Documents\DNA methylation data analyzed by - Dr. Dongmei Li\Manhattan Plot and Volcano plot\Box Plot\boxplot_all_samples (1).tif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819400" y="-152400"/>
              <a:ext cx="3657600" cy="731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767463" y="3231813"/>
              <a:ext cx="723275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value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1791100" y="5238550"/>
              <a:ext cx="2011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886200" y="5238550"/>
              <a:ext cx="2011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5989320" y="5238550"/>
              <a:ext cx="2011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253671" y="5248977"/>
              <a:ext cx="874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n-smoker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82471" y="5248175"/>
              <a:ext cx="6242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moker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39177" y="5248175"/>
              <a:ext cx="4715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PD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1693888" y="612753"/>
            <a:ext cx="927891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hows distribution of pre-processed DNA methylation level (β values) from all the samples and different groups used for comparison. </a:t>
            </a:r>
          </a:p>
        </p:txBody>
      </p:sp>
    </p:spTree>
    <p:extLst>
      <p:ext uri="{BB962C8B-B14F-4D97-AF65-F5344CB8AC3E}">
        <p14:creationId xmlns:p14="http://schemas.microsoft.com/office/powerpoint/2010/main" val="41054519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1295" y="45391"/>
            <a:ext cx="18955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10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" t="6349" r="-114" b="4000"/>
          <a:stretch/>
        </p:blipFill>
        <p:spPr>
          <a:xfrm>
            <a:off x="2879818" y="1581312"/>
            <a:ext cx="6448698" cy="5203179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539070" y="365761"/>
            <a:ext cx="1099108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yrosequencing validation of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for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OS1AP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oxplots represent pyrosequencing methylation percentages between different experimental groups (Smokers and COPD) compared to non-smokers control for the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that were close to 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NOS1A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locus cg2663636 identified by genome-wide DNA methylation analysis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are represented as box plot which displays the full range of variation (from min to max), the likely range of variation (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a typical value (the median) for n = 8/group and the significance determined using 1-way ANOVA (Tukey’s multiple comparisons test). 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5, *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1, ***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01, vs. non-smokers.</a:t>
            </a:r>
          </a:p>
        </p:txBody>
      </p:sp>
    </p:spTree>
    <p:extLst>
      <p:ext uri="{BB962C8B-B14F-4D97-AF65-F5344CB8AC3E}">
        <p14:creationId xmlns:p14="http://schemas.microsoft.com/office/powerpoint/2010/main" val="199557780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15" t="10159" r="7258" b="1968"/>
          <a:stretch/>
        </p:blipFill>
        <p:spPr>
          <a:xfrm>
            <a:off x="3293057" y="1515300"/>
            <a:ext cx="5602028" cy="5259977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670560" y="345607"/>
            <a:ext cx="1081604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yrosequencing validation of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for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NFAIP2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oxplots represent pyrosequencing methylation percentages between different experimental groups (Smokers and COPD) compared to non-smokers control for the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that were close to the TNFAIP2 locus cg18620571 identified by genome-wide DNA methylation analysis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are represented as box plot which displays the full range of variation (from min to max), the likely range of variation (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a typical value (the median) for n = 8/group and the significance determined using 1-way ANOVA (Tukey’s multiple comparisons test).</a:t>
            </a:r>
          </a:p>
        </p:txBody>
      </p:sp>
      <p:sp>
        <p:nvSpPr>
          <p:cNvPr id="16" name="Rectangle 15"/>
          <p:cNvSpPr/>
          <p:nvPr/>
        </p:nvSpPr>
        <p:spPr>
          <a:xfrm>
            <a:off x="81295" y="45391"/>
            <a:ext cx="18955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11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8075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96686" y="361067"/>
            <a:ext cx="1072896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yrosequencing validation of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for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I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GABRB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Boxplots represent pyrosequencing methylation percentages between different experimental groups (Smokers and COPD) compared to non-smokers control for the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that were close to 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I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locus cg01388022,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GABRB1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ocus cg15393297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dentified by genome-wide DNA methylation analysis. Data are represented as box plot which displays the full range of variation (from min to max), the likely range of variation (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a typical value (the median) for n = 8/group and the significance determined using 1-way ANOVA (Tukey’s multiple comparisons test). 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5, *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1, ***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01, vs. non-smokers.</a:t>
            </a:r>
          </a:p>
        </p:txBody>
      </p:sp>
      <p:sp>
        <p:nvSpPr>
          <p:cNvPr id="31" name="Rectangle 30"/>
          <p:cNvSpPr/>
          <p:nvPr/>
        </p:nvSpPr>
        <p:spPr>
          <a:xfrm>
            <a:off x="81295" y="45391"/>
            <a:ext cx="18955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12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14" b="31302"/>
          <a:stretch/>
        </p:blipFill>
        <p:spPr>
          <a:xfrm>
            <a:off x="1110557" y="1746062"/>
            <a:ext cx="10140917" cy="5018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3928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22811" y="358136"/>
            <a:ext cx="1072895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yrosequencing validation of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for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TXN7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HOC7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Boxplots represent pyrosequencing methylation percentages between different experimental groups (Smokers and COPD) compared to non-smokers control for the addition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tes that were close to 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TXN7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HOC7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locus cg07753241 identified by genome-wide DNA methylation. Data are represented as box plot which displays the full range of variation (from min to max), the likely range of variation (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Q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a typical value (the median) for n = 8/group and the significance determined using 1-way ANOVA (Tukey’s multiple comparisons test). 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" t="7237" r="5658" b="2476"/>
          <a:stretch/>
        </p:blipFill>
        <p:spPr>
          <a:xfrm>
            <a:off x="3207399" y="1596726"/>
            <a:ext cx="5782492" cy="5091458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81295" y="45391"/>
            <a:ext cx="18955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13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0257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1601" y="116926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endParaRPr lang="en-US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6" descr="C:\Users\isundar\Desktop\DNA methylation MS files\venn_result22236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8877" y="2710710"/>
            <a:ext cx="33528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5" descr="C:\Users\isundar\Desktop\DNA methylation MS files\Venn Diagrams\venn_result24034.png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4000" y="2703491"/>
            <a:ext cx="33528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564074" y="827968"/>
            <a:ext cx="889406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en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iagrams shows DNA methylation loci that were identified to be overlapping and or shared between different groups such as Non-smokers vs. Smokers (NS vs. S) compared to Non-smokers vs. COPD (NS vs. C) and Smoker vs. COPD (S vs. C) with significant differential DNA methylation status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&lt; 0.001 an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&lt; 0.01 </a:t>
            </a:r>
          </a:p>
        </p:txBody>
      </p:sp>
    </p:spTree>
    <p:extLst>
      <p:ext uri="{BB962C8B-B14F-4D97-AF65-F5344CB8AC3E}">
        <p14:creationId xmlns:p14="http://schemas.microsoft.com/office/powerpoint/2010/main" val="27481505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634845" y="2146663"/>
            <a:ext cx="10860505" cy="3711580"/>
            <a:chOff x="610781" y="1934645"/>
            <a:chExt cx="10860505" cy="3711580"/>
          </a:xfrm>
        </p:grpSpPr>
        <p:sp>
          <p:nvSpPr>
            <p:cNvPr id="2" name="矩形 1"/>
            <p:cNvSpPr/>
            <p:nvPr/>
          </p:nvSpPr>
          <p:spPr>
            <a:xfrm>
              <a:off x="610781" y="3876510"/>
              <a:ext cx="10860505" cy="17697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kern="0" dirty="0" smtClean="0">
                  <a:solidFill>
                    <a:srgbClr val="000000"/>
                  </a:solidFill>
                  <a:latin typeface="Arial" charset="0"/>
                  <a:ea typeface="Times New Roman" charset="0"/>
                  <a:cs typeface="Times New Roman" charset="0"/>
                </a:rPr>
                <a:t>TGGAGATCACCTTCCGCTCCGGAGCCCTGCCCGTGCTCTGTGACCCCACGACCCCTAAGCCAGAGGACCTGCATTCGCCGCCGCTGGGCGCGGGCTTGGCTGACTTTGCCCACCCTGCGGGCAGCCCCTTAGGTAGGCGCGAC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  <a:cs typeface="Times New Roman" charset="0"/>
                </a:rPr>
                <a:t>TGCTTGGTGAAGCTGGAGTGCTTTC</a:t>
              </a:r>
            </a:p>
            <a:p>
              <a:r>
                <a:rPr lang="en-US" altLang="zh-CN" sz="1100" b="1" kern="0" dirty="0" smtClean="0">
                  <a:solidFill>
                    <a:srgbClr val="000000"/>
                  </a:solidFill>
                  <a:latin typeface="Arial" charset="0"/>
                  <a:ea typeface="Times New Roman" charset="0"/>
                  <a:cs typeface="Times New Roman" charset="0"/>
                </a:rPr>
                <a:t>                                                                                                                                                                                                                                                              CpG_1</a:t>
              </a:r>
              <a:endParaRPr lang="en-US" altLang="zh-CN" sz="1100" b="1" kern="0" dirty="0">
                <a:solidFill>
                  <a:srgbClr val="000000"/>
                </a:solidFill>
                <a:highlight>
                  <a:srgbClr val="FFFF00"/>
                </a:highlight>
                <a:latin typeface="Arial" charset="0"/>
                <a:ea typeface="Times New Roman" charset="0"/>
                <a:cs typeface="Times New Roman" charset="0"/>
              </a:endParaRPr>
            </a:p>
            <a:p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  <a:cs typeface="Times New Roman" charset="0"/>
                </a:rPr>
                <a:t>GCTTTCTTCCGCCCGAGGACACCCCGCCCCCAGCGCAGGGCGAGGCGCTCCTGGGCGGTCTGGAGCTCATCAAGTT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AGAGT</a:t>
              </a:r>
            </a:p>
            <a:p>
              <a:r>
                <a:rPr lang="en-US" altLang="zh-CN" sz="1100" b="1" kern="0" dirty="0" smtClean="0">
                  <a:solidFill>
                    <a:srgbClr val="000000"/>
                  </a:solidFill>
                  <a:latin typeface="Arial" charset="0"/>
                  <a:ea typeface="Times New Roman" charset="0"/>
                  <a:cs typeface="Times New Roman" charset="0"/>
                </a:rPr>
                <a:t>                     CpG_2     CpG_3           CpG_4                         CpG_5  CpG_6       CpG7              CpG_8,9         CpG_10                                                        CpG_11</a:t>
              </a:r>
              <a:endParaRPr lang="en-US" altLang="zh-CN" sz="1100" b="1" kern="0" dirty="0">
                <a:solidFill>
                  <a:srgbClr val="000000"/>
                </a:solidFill>
                <a:highlight>
                  <a:srgbClr val="00FF00"/>
                </a:highlight>
                <a:latin typeface="Arial" charset="0"/>
                <a:ea typeface="Times New Roman" charset="0"/>
                <a:cs typeface="Times New Roman" charset="0"/>
              </a:endParaRPr>
            </a:p>
            <a:p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AGGCAT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CT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GAGTA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AGTCCAACA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GA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AGAG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AGGAG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ACT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TGGTCCCAGGAGGAGCTGC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  <a:cs typeface="Times New Roman" charset="0"/>
                </a:rPr>
                <a:t>C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  <a:cs typeface="Times New Roman" charset="0"/>
                </a:rPr>
                <a:t>GCCTGCTGAATGTCCTGCAGAGGCAGGAACTGGG</a:t>
              </a:r>
              <a:r>
                <a:rPr lang="en-US" altLang="zh-CN" sz="1400" kern="0" dirty="0" smtClean="0">
                  <a:solidFill>
                    <a:srgbClr val="000000"/>
                  </a:solidFill>
                  <a:latin typeface="Arial" charset="0"/>
                  <a:ea typeface="Times New Roman" charset="0"/>
                  <a:cs typeface="Times New Roman" charset="0"/>
                </a:rPr>
                <a:t>CGACGGCCTGGATGATGAGATCGCCGTGTAGGTGCCGAGGGCGAGGAGATGGAGGCGGCGGCGTGGCTGGAGGGGCCGTGTCTGGCTGCTGCCCGGGTAGGGGATGCCC </a:t>
              </a:r>
              <a:r>
                <a:rPr lang="en-US" altLang="zh-CN" sz="1400" kern="0" dirty="0">
                  <a:solidFill>
                    <a:srgbClr val="000000"/>
                  </a:solidFill>
                  <a:latin typeface="Arial" charset="0"/>
                  <a:ea typeface="Times New Roman" charset="0"/>
                  <a:cs typeface="Times New Roman" charset="0"/>
                </a:rPr>
                <a:t>AGTGAATGTGCACTGCCGAGGAGAATG</a:t>
              </a:r>
              <a:endParaRPr lang="zh-CN" altLang="zh-CN" sz="1400" kern="100" dirty="0">
                <a:latin typeface="Cambria" charset="0"/>
                <a:cs typeface="Times New Roman" charset="0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>
              <a:off x="760675" y="2933163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右箭头 4"/>
            <p:cNvSpPr/>
            <p:nvPr/>
          </p:nvSpPr>
          <p:spPr>
            <a:xfrm>
              <a:off x="1193399" y="3225938"/>
              <a:ext cx="7255240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310435" y="3449546"/>
              <a:ext cx="3432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NOS1AP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26663636)</a:t>
              </a:r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7" name="直线连接符 6"/>
            <p:cNvCxnSpPr/>
            <p:nvPr/>
          </p:nvCxnSpPr>
          <p:spPr>
            <a:xfrm flipV="1">
              <a:off x="2544995" y="261928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线连接符 7"/>
            <p:cNvCxnSpPr/>
            <p:nvPr/>
          </p:nvCxnSpPr>
          <p:spPr>
            <a:xfrm flipV="1">
              <a:off x="3592756" y="2214961"/>
              <a:ext cx="0" cy="98176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线连接符 8"/>
            <p:cNvCxnSpPr/>
            <p:nvPr/>
          </p:nvCxnSpPr>
          <p:spPr>
            <a:xfrm flipV="1">
              <a:off x="4138461" y="262673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线连接符 9"/>
            <p:cNvCxnSpPr/>
            <p:nvPr/>
          </p:nvCxnSpPr>
          <p:spPr>
            <a:xfrm flipV="1">
              <a:off x="4788682" y="2625614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/>
            <p:cNvSpPr txBox="1"/>
            <p:nvPr/>
          </p:nvSpPr>
          <p:spPr>
            <a:xfrm>
              <a:off x="1437039" y="2348066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218096" y="2335702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2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782786" y="2326558"/>
              <a:ext cx="6493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3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848904" y="1934645"/>
              <a:ext cx="15710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_4 (cg26663636) 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V="1">
              <a:off x="1768666" y="261928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线连接符 15"/>
            <p:cNvCxnSpPr/>
            <p:nvPr/>
          </p:nvCxnSpPr>
          <p:spPr>
            <a:xfrm flipV="1">
              <a:off x="3042005" y="261928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3820394" y="2326558"/>
              <a:ext cx="707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5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4485312" y="2326558"/>
              <a:ext cx="6714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6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1" name="直线连接符 30"/>
            <p:cNvCxnSpPr/>
            <p:nvPr/>
          </p:nvCxnSpPr>
          <p:spPr>
            <a:xfrm flipV="1">
              <a:off x="5384835" y="262403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线连接符 32"/>
            <p:cNvCxnSpPr/>
            <p:nvPr/>
          </p:nvCxnSpPr>
          <p:spPr>
            <a:xfrm flipV="1">
              <a:off x="6644376" y="262403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线连接符 33"/>
            <p:cNvCxnSpPr/>
            <p:nvPr/>
          </p:nvCxnSpPr>
          <p:spPr>
            <a:xfrm flipV="1">
              <a:off x="7509470" y="2632276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/>
          </p:nvSpPr>
          <p:spPr>
            <a:xfrm>
              <a:off x="5081138" y="2340156"/>
              <a:ext cx="6714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7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5615185" y="1951104"/>
              <a:ext cx="797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8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6308668" y="2323084"/>
              <a:ext cx="739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smtClean="0">
                  <a:latin typeface="Arial" charset="0"/>
                  <a:ea typeface="Arial" charset="0"/>
                  <a:cs typeface="Arial" charset="0"/>
                </a:rPr>
                <a:t>CpG_10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7131626" y="2323084"/>
              <a:ext cx="7410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smtClean="0">
                  <a:latin typeface="Arial" charset="0"/>
                  <a:ea typeface="Arial" charset="0"/>
                  <a:cs typeface="Arial" charset="0"/>
                </a:rPr>
                <a:t>CpG_11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6087101" y="2255769"/>
              <a:ext cx="91440" cy="962035"/>
              <a:chOff x="5786309" y="1985383"/>
              <a:chExt cx="195719" cy="962035"/>
            </a:xfrm>
          </p:grpSpPr>
          <p:cxnSp>
            <p:nvCxnSpPr>
              <p:cNvPr id="40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 flipH="1">
              <a:off x="6206291" y="2254582"/>
              <a:ext cx="91440" cy="962035"/>
              <a:chOff x="5786309" y="1985383"/>
              <a:chExt cx="195719" cy="962035"/>
            </a:xfrm>
          </p:grpSpPr>
          <p:cxnSp>
            <p:nvCxnSpPr>
              <p:cNvPr id="43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文本框 35"/>
            <p:cNvSpPr txBox="1"/>
            <p:nvPr/>
          </p:nvSpPr>
          <p:spPr>
            <a:xfrm>
              <a:off x="6152609" y="1947088"/>
              <a:ext cx="797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9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84739" y="743672"/>
            <a:ext cx="1051809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NOS1A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26663636)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NOS1A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~ 334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26663636) is shown.</a:t>
            </a:r>
          </a:p>
        </p:txBody>
      </p:sp>
    </p:spTree>
    <p:extLst>
      <p:ext uri="{BB962C8B-B14F-4D97-AF65-F5344CB8AC3E}">
        <p14:creationId xmlns:p14="http://schemas.microsoft.com/office/powerpoint/2010/main" val="18883533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578224" y="2153397"/>
            <a:ext cx="11053482" cy="3755286"/>
            <a:chOff x="578224" y="1689107"/>
            <a:chExt cx="11053482" cy="3755286"/>
          </a:xfrm>
        </p:grpSpPr>
        <p:sp>
          <p:nvSpPr>
            <p:cNvPr id="2" name="矩形 1"/>
            <p:cNvSpPr/>
            <p:nvPr/>
          </p:nvSpPr>
          <p:spPr>
            <a:xfrm>
              <a:off x="578224" y="3720844"/>
              <a:ext cx="11053482" cy="17235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kern="100" dirty="0" smtClean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AGGCGGCGCGGCCGCTGCTGGCGCTGGAGCGGGAGCTGGCGGCGGCGGCGGCGGCGGGCGGTGTGAGCGAGGAGGAGCTGGT</a:t>
              </a:r>
            </a:p>
            <a:p>
              <a:r>
                <a:rPr lang="en-US" altLang="zh-CN" sz="1100" b="1" kern="100" dirty="0" smtClean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                                                                            CpG_1            CpG_2                     CpG_3,4                                         CpG_5           CpG_6,CpG_7  CpG_8                  CpG_9,10</a:t>
              </a:r>
              <a:endParaRPr lang="en-US" altLang="zh-CN" sz="1100" b="1" kern="100" dirty="0">
                <a:solidFill>
                  <a:srgbClr val="000000"/>
                </a:solidFill>
                <a:latin typeface="Arial" charset="0"/>
                <a:ea typeface="Courier" charset="0"/>
                <a:cs typeface="Times New Roman" charset="0"/>
              </a:endParaRPr>
            </a:p>
            <a:p>
              <a:r>
                <a:rPr lang="en-US" altLang="zh-CN" sz="1400" kern="100" dirty="0" smtClean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GCGGC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Courier" charset="0"/>
                  <a:cs typeface="Times New Roman" charset="0"/>
                </a:rPr>
                <a:t>GCCAGAGCAAGGTGGAG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TGTA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AGCTGCT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ACCAGGTGCTGG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TGCT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GC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TGGAG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</a:t>
              </a:r>
            </a:p>
            <a:p>
              <a:r>
                <a:rPr lang="en-US" altLang="zh-CN" sz="1100" b="1" kern="100" dirty="0" smtClean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        CpG_11</a:t>
              </a:r>
              <a:endParaRPr lang="en-US" altLang="zh-CN" sz="1100" b="1" kern="100" dirty="0">
                <a:solidFill>
                  <a:srgbClr val="FF0000"/>
                </a:solidFill>
                <a:highlight>
                  <a:srgbClr val="00FF00"/>
                </a:highlight>
                <a:latin typeface="Arial" charset="0"/>
                <a:ea typeface="Courier" charset="0"/>
                <a:cs typeface="Times New Roman" charset="0"/>
              </a:endParaRPr>
            </a:p>
            <a:p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C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A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GCT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CAGG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TGGC</a:t>
              </a:r>
              <a:r>
                <a:rPr lang="en-US" altLang="zh-CN" sz="1400" kern="1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CG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Courier" charset="0"/>
                  <a:cs typeface="Times New Roman" charset="0"/>
                </a:rPr>
                <a:t>TGGTGGC</a:t>
              </a:r>
              <a:r>
                <a:rPr lang="en-US" altLang="zh-CN" sz="1400" kern="1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Courier" charset="0"/>
                  <a:cs typeface="Times New Roman" charset="0"/>
                </a:rPr>
                <a:t>GGAGCAGGAGCGCGAGGACCGCCAGGCGGCGGCGGCGGGGCCGGGGACCTCGGGGCTGGCGGCCACGCGCCCGCGGCGCTGGCTGCAGCTGTGGCGGCGCGGCGTGGCGGAGGCGGCCGAGGAGCGCATGGGCCAGCGGCCGGCCGCGGGCGCCGAGGTCCCCGAGAGCGTCTTTCTGCACTTGGGCCGCACCATGAAGGAGGACCTGG</a:t>
              </a:r>
              <a:r>
                <a:rPr lang="en-US" altLang="zh-CN" sz="1400" kern="100" dirty="0" smtClean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AGGCCGTGGTGGAGCGGCTGAAGCCGCTGTTCCCCGCCGAGTTCGGCGTCGTGGCGGCCTACGCC </a:t>
              </a:r>
              <a:r>
                <a:rPr lang="en-US" altLang="zh-CN" sz="1400" kern="100" dirty="0">
                  <a:solidFill>
                    <a:srgbClr val="000000"/>
                  </a:solidFill>
                  <a:latin typeface="Arial" charset="0"/>
                  <a:ea typeface="Courier" charset="0"/>
                  <a:cs typeface="Times New Roman" charset="0"/>
                </a:rPr>
                <a:t>GAGAGCTACCACCAGCACTTCGCG</a:t>
              </a:r>
              <a:endParaRPr lang="zh-CN" altLang="zh-CN" sz="1400" kern="100" dirty="0">
                <a:latin typeface="Cambria" charset="0"/>
                <a:cs typeface="Times New Roman" charset="0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>
              <a:off x="894280" y="2671643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右箭头 4"/>
            <p:cNvSpPr/>
            <p:nvPr/>
          </p:nvSpPr>
          <p:spPr>
            <a:xfrm>
              <a:off x="1327004" y="2952386"/>
              <a:ext cx="9287444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393101" y="3197624"/>
              <a:ext cx="3432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TNFAIP2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18620571)</a:t>
              </a:r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7" name="直线连接符 6"/>
            <p:cNvCxnSpPr/>
            <p:nvPr/>
          </p:nvCxnSpPr>
          <p:spPr>
            <a:xfrm flipV="1">
              <a:off x="2678600" y="235776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线连接符 7"/>
            <p:cNvCxnSpPr/>
            <p:nvPr/>
          </p:nvCxnSpPr>
          <p:spPr>
            <a:xfrm flipH="1" flipV="1">
              <a:off x="3716107" y="2365212"/>
              <a:ext cx="10254" cy="56999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线连接符 8"/>
            <p:cNvCxnSpPr/>
            <p:nvPr/>
          </p:nvCxnSpPr>
          <p:spPr>
            <a:xfrm flipV="1">
              <a:off x="4272066" y="236521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线连接符 9"/>
            <p:cNvCxnSpPr/>
            <p:nvPr/>
          </p:nvCxnSpPr>
          <p:spPr>
            <a:xfrm flipV="1">
              <a:off x="4922287" y="2364094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/>
            <p:cNvSpPr txBox="1"/>
            <p:nvPr/>
          </p:nvSpPr>
          <p:spPr>
            <a:xfrm>
              <a:off x="1570644" y="2086546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351701" y="2074182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2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627901" y="1723687"/>
              <a:ext cx="6474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3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V="1">
              <a:off x="1902271" y="235776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3372452" y="2066242"/>
              <a:ext cx="707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5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974376" y="2061564"/>
              <a:ext cx="6714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6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" name="直线连接符 18"/>
            <p:cNvCxnSpPr/>
            <p:nvPr/>
          </p:nvCxnSpPr>
          <p:spPr>
            <a:xfrm flipV="1">
              <a:off x="5518440" y="236251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线连接符 20"/>
            <p:cNvCxnSpPr/>
            <p:nvPr/>
          </p:nvCxnSpPr>
          <p:spPr>
            <a:xfrm flipV="1">
              <a:off x="6777981" y="236251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4621287" y="2061564"/>
              <a:ext cx="6714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7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5148686" y="2067678"/>
              <a:ext cx="797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8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5540180" y="1689107"/>
              <a:ext cx="7145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9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6473475" y="2067678"/>
              <a:ext cx="7410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1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6014909" y="1979033"/>
              <a:ext cx="91440" cy="962035"/>
              <a:chOff x="5786309" y="1985383"/>
              <a:chExt cx="195719" cy="962035"/>
            </a:xfrm>
          </p:grpSpPr>
          <p:cxnSp>
            <p:nvCxnSpPr>
              <p:cNvPr id="20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 32"/>
            <p:cNvGrpSpPr/>
            <p:nvPr/>
          </p:nvGrpSpPr>
          <p:grpSpPr>
            <a:xfrm flipH="1">
              <a:off x="6134099" y="1977846"/>
              <a:ext cx="91440" cy="962035"/>
              <a:chOff x="5786309" y="1985383"/>
              <a:chExt cx="195719" cy="962035"/>
            </a:xfrm>
          </p:grpSpPr>
          <p:cxnSp>
            <p:nvCxnSpPr>
              <p:cNvPr id="34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文本框 24"/>
            <p:cNvSpPr txBox="1"/>
            <p:nvPr/>
          </p:nvSpPr>
          <p:spPr>
            <a:xfrm>
              <a:off x="6022780" y="1689107"/>
              <a:ext cx="9087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0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3103942" y="1982613"/>
              <a:ext cx="91440" cy="962035"/>
              <a:chOff x="5786309" y="1985383"/>
              <a:chExt cx="195719" cy="962035"/>
            </a:xfrm>
          </p:grpSpPr>
          <p:cxnSp>
            <p:nvCxnSpPr>
              <p:cNvPr id="38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Group 39"/>
            <p:cNvGrpSpPr/>
            <p:nvPr/>
          </p:nvGrpSpPr>
          <p:grpSpPr>
            <a:xfrm flipH="1">
              <a:off x="3223132" y="1981426"/>
              <a:ext cx="91440" cy="962035"/>
              <a:chOff x="5786309" y="1985383"/>
              <a:chExt cx="195719" cy="962035"/>
            </a:xfrm>
          </p:grpSpPr>
          <p:cxnSp>
            <p:nvCxnSpPr>
              <p:cNvPr id="41" name="直线连接符 19"/>
              <p:cNvCxnSpPr/>
              <p:nvPr/>
            </p:nvCxnSpPr>
            <p:spPr>
              <a:xfrm flipV="1">
                <a:off x="5972071" y="2215898"/>
                <a:ext cx="9745" cy="73152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线连接符 19"/>
              <p:cNvCxnSpPr/>
              <p:nvPr/>
            </p:nvCxnSpPr>
            <p:spPr>
              <a:xfrm flipH="1" flipV="1">
                <a:off x="5786309" y="1985383"/>
                <a:ext cx="195719" cy="2321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文本框 12"/>
            <p:cNvSpPr txBox="1"/>
            <p:nvPr/>
          </p:nvSpPr>
          <p:spPr>
            <a:xfrm>
              <a:off x="3148601" y="1723687"/>
              <a:ext cx="17679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_4 (cg18620571) 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894281" y="763971"/>
            <a:ext cx="1051809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TNFAIP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18620571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TNFAIP2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~324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18620571) is shown.</a:t>
            </a:r>
          </a:p>
        </p:txBody>
      </p:sp>
    </p:spTree>
    <p:extLst>
      <p:ext uri="{BB962C8B-B14F-4D97-AF65-F5344CB8AC3E}">
        <p14:creationId xmlns:p14="http://schemas.microsoft.com/office/powerpoint/2010/main" val="18374686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781985" y="2190918"/>
            <a:ext cx="10546211" cy="3122213"/>
            <a:chOff x="781985" y="2041418"/>
            <a:chExt cx="10546211" cy="3122213"/>
          </a:xfrm>
        </p:grpSpPr>
        <p:sp>
          <p:nvSpPr>
            <p:cNvPr id="8" name="矩形 7"/>
            <p:cNvSpPr/>
            <p:nvPr/>
          </p:nvSpPr>
          <p:spPr>
            <a:xfrm>
              <a:off x="781985" y="2639321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9" name="右箭头 8"/>
            <p:cNvSpPr/>
            <p:nvPr/>
          </p:nvSpPr>
          <p:spPr>
            <a:xfrm>
              <a:off x="1860884" y="2904169"/>
              <a:ext cx="8919411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340682" y="3127159"/>
              <a:ext cx="3432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BID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01388022)</a:t>
              </a:r>
              <a:r>
                <a:rPr lang="zh-CN" altLang="zh-CN" sz="1400" b="1" dirty="0" smtClean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V="1">
              <a:off x="2417505" y="228352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线连接符 15"/>
            <p:cNvCxnSpPr/>
            <p:nvPr/>
          </p:nvCxnSpPr>
          <p:spPr>
            <a:xfrm flipV="1">
              <a:off x="3389351" y="2283521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线连接符 16"/>
            <p:cNvCxnSpPr/>
            <p:nvPr/>
          </p:nvCxnSpPr>
          <p:spPr>
            <a:xfrm flipV="1">
              <a:off x="3851779" y="2283520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线连接符 17"/>
            <p:cNvCxnSpPr/>
            <p:nvPr/>
          </p:nvCxnSpPr>
          <p:spPr>
            <a:xfrm flipV="1">
              <a:off x="4699464" y="228345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2133599" y="2042614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070763" y="2041418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2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3592041" y="2041418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3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4228711" y="2041418"/>
              <a:ext cx="16091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_4 (cg01388022)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" name="矩形 1"/>
            <p:cNvSpPr/>
            <p:nvPr/>
          </p:nvSpPr>
          <p:spPr>
            <a:xfrm>
              <a:off x="785068" y="3563193"/>
              <a:ext cx="10543128" cy="16004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kern="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CTAACTCAGAAACAGAAAATCAAATACTGACTGTTCTCACTTATAAGTG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Arial" charset="0"/>
                  <a:cs typeface="Arial" charset="0"/>
                </a:rPr>
                <a:t>GAGCTAAACAATGGGTGCCCATGGACACGAAGAT</a:t>
              </a:r>
            </a:p>
            <a:p>
              <a:r>
                <a:rPr lang="en-US" altLang="zh-CN" sz="1100" b="1" kern="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                                                CpG_1                                                            CpG_2          CpG_3                   CpG_4</a:t>
              </a:r>
              <a:endParaRPr lang="en-US" altLang="zh-CN" sz="1100" b="1" kern="0" dirty="0">
                <a:solidFill>
                  <a:srgbClr val="000000"/>
                </a:solidFill>
                <a:highlight>
                  <a:srgbClr val="FFFF00"/>
                </a:highlight>
                <a:latin typeface="Arial" charset="0"/>
                <a:ea typeface="Arial" charset="0"/>
                <a:cs typeface="Arial" charset="0"/>
              </a:endParaRPr>
            </a:p>
            <a:p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Arial" charset="0"/>
                  <a:cs typeface="Arial" charset="0"/>
                </a:rPr>
                <a:t>GGAGAGAGCAGGC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AC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GGCACTTTACAGTAGGGAGG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GGGG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G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GGGGAG</a:t>
              </a:r>
              <a:r>
                <a:rPr lang="en-US" altLang="zh-CN" sz="1400" kern="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G</a:t>
              </a:r>
              <a:r>
                <a:rPr lang="en-US" altLang="zh-CN" sz="1400" kern="0" dirty="0" smtClean="0"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altLang="zh-CN" sz="1400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Arial" charset="0"/>
                  <a:cs typeface="Arial" charset="0"/>
                </a:rPr>
                <a:t>AGAAAGAGTCCCTCTCCATGCGATACCGGAAGCCCAGTCCCCACCAGTGCACAATATTCCCATGTGACAAACATGTACACGTGCCCCTGAATCTAAAATAAAATAAAATAAGGTGCTTGTGTATTGCTATTCAGCCTTTACTTCTCCAAAGTTGTTTCTGAAGAGAGGAAAAACTGTATGCAAAATTCCACTGCATCAATTCCTAACAATTCTTGTACGGAGCAGCCGCATGGCACAAGACAGCTTACAAACAGGATGTGCTTCATTCCTGCCTCAAGCGACAGTCCTGGTGACACAGTTAGTGCTGGGCTA</a:t>
              </a:r>
              <a:r>
                <a:rPr lang="en-US" altLang="zh-CN" sz="1400" kern="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AGCTGTGTCACCCAAAAAGAAAAGCGCAAGTCCTAACCCCAAGTACCTGT</a:t>
              </a:r>
              <a:endParaRPr lang="zh-CN" altLang="zh-CN" sz="1400" kern="1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781986" y="762903"/>
            <a:ext cx="1052322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BID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1388022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BID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~400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1388022) is shown.</a:t>
            </a:r>
          </a:p>
        </p:txBody>
      </p:sp>
    </p:spTree>
    <p:extLst>
      <p:ext uri="{BB962C8B-B14F-4D97-AF65-F5344CB8AC3E}">
        <p14:creationId xmlns:p14="http://schemas.microsoft.com/office/powerpoint/2010/main" val="20936896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46324" y="1975987"/>
            <a:ext cx="10540037" cy="3476911"/>
            <a:chOff x="746324" y="1922543"/>
            <a:chExt cx="10540037" cy="3476911"/>
          </a:xfrm>
        </p:grpSpPr>
        <p:sp>
          <p:nvSpPr>
            <p:cNvPr id="4" name="矩形 3"/>
            <p:cNvSpPr/>
            <p:nvPr/>
          </p:nvSpPr>
          <p:spPr>
            <a:xfrm>
              <a:off x="746324" y="2793917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右箭头 4"/>
            <p:cNvSpPr/>
            <p:nvPr/>
          </p:nvSpPr>
          <p:spPr>
            <a:xfrm>
              <a:off x="1249640" y="3089498"/>
              <a:ext cx="8965604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288999" y="3326876"/>
              <a:ext cx="34327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GABRB1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15393297)</a:t>
              </a:r>
              <a:r>
                <a:rPr lang="zh-CN" altLang="zh-CN" sz="1400" b="1" dirty="0" smtClean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endParaRPr kumimoji="1" lang="en-US" altLang="zh-CN" sz="1400" b="1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ctr"/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7" name="直线连接符 6"/>
            <p:cNvCxnSpPr/>
            <p:nvPr/>
          </p:nvCxnSpPr>
          <p:spPr>
            <a:xfrm flipV="1">
              <a:off x="2381844" y="2492070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线连接符 7"/>
            <p:cNvCxnSpPr/>
            <p:nvPr/>
          </p:nvCxnSpPr>
          <p:spPr>
            <a:xfrm flipV="1">
              <a:off x="3585876" y="2501246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线连接符 8"/>
            <p:cNvCxnSpPr/>
            <p:nvPr/>
          </p:nvCxnSpPr>
          <p:spPr>
            <a:xfrm flipV="1">
              <a:off x="4124110" y="249951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线连接符 9"/>
            <p:cNvCxnSpPr/>
            <p:nvPr/>
          </p:nvCxnSpPr>
          <p:spPr>
            <a:xfrm flipV="1">
              <a:off x="4774331" y="2498400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/>
            <p:cNvSpPr txBox="1"/>
            <p:nvPr/>
          </p:nvSpPr>
          <p:spPr>
            <a:xfrm>
              <a:off x="1188772" y="1922543"/>
              <a:ext cx="221820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_1 (</a:t>
              </a:r>
              <a:r>
                <a:rPr kumimoji="1" lang="en-US" altLang="zh-CN" sz="1100" b="1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g15393297)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 algn="ctr"/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080175" y="2208488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2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694293" y="2199344"/>
              <a:ext cx="7126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3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3272607" y="2211317"/>
              <a:ext cx="707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4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H="1" flipV="1">
              <a:off x="1731624" y="2208488"/>
              <a:ext cx="0" cy="861023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线连接符 15"/>
            <p:cNvCxnSpPr/>
            <p:nvPr/>
          </p:nvCxnSpPr>
          <p:spPr>
            <a:xfrm flipV="1">
              <a:off x="3027654" y="2492068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3806043" y="2199344"/>
              <a:ext cx="707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5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4470961" y="2199344"/>
              <a:ext cx="15733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6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802232" y="3799016"/>
              <a:ext cx="10484129" cy="16004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dist"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CCATTAGAACAGACCTCAGTGTACATAGTAAAGCCAATAGACGACATTAAAAAGAGAAAAGGTGATGGGGAAAAACATTCG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</a:rPr>
                <a:t>GACCACTTGTCTATGGAATTCACATCAGTCAAGTCGGGGATCTTGACTTTGAGCTGGGAGGCACGCCTGCGGATGCGCCCCTTGCTGGGTACCCCGTGCCGGTCCAGGGCGCGCCCGTAGGCCTCGCGGCTGCTCAGGGGCTTGCGGTACTGGATGCTGGCGCTGT</a:t>
              </a:r>
            </a:p>
            <a:p>
              <a:r>
                <a:rPr lang="en-US" altLang="zh-CN" sz="1100" b="1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                                                                                      CpG_1        CpG_2  CpG_3                         CpG_4                   CpG_5                   CpG_6</a:t>
              </a:r>
              <a:endParaRPr lang="en-US" altLang="zh-CN" sz="1100" b="1" dirty="0">
                <a:solidFill>
                  <a:srgbClr val="000000"/>
                </a:solidFill>
                <a:highlight>
                  <a:srgbClr val="FFFF00"/>
                </a:highlight>
                <a:latin typeface="Arial" charset="0"/>
                <a:ea typeface="Times New Roman" charset="0"/>
              </a:endParaRPr>
            </a:p>
            <a:p>
              <a:pPr algn="dist"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</a:rPr>
                <a:t>CATAGGAGTACATGGTGGCC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TTGGGGT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TCA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T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TGAGCACTT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AGCCACT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TCTCATT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Times New Roman" charset="0"/>
                </a:rPr>
                <a:t>GATTTCCAGGGTGCTGAGGAGAAT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Times New Roman" charset="0"/>
                </a:rPr>
                <a:t>TTACCGTGGGCGTCGACCTGATGGCAAAAAGAACAGGCTCGGACACAAGTTGCAGGACCTTTGCCTGTTTTCATTAAC</a:t>
              </a: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CTGTTACTAATGATACCCCATAAGGCTCATTAAACACTGTGTTCCTAAACATCTGGCTTGATGTGCCTCCCTGATGTGG</a:t>
              </a:r>
              <a:endParaRPr lang="zh-CN" altLang="zh-CN" sz="1400" dirty="0">
                <a:latin typeface="Times New Roman" charset="0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46324" y="763972"/>
            <a:ext cx="1051809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GABRB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15393297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GABRB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~ 339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15393297) is shown.</a:t>
            </a:r>
          </a:p>
        </p:txBody>
      </p:sp>
    </p:spTree>
    <p:extLst>
      <p:ext uri="{BB962C8B-B14F-4D97-AF65-F5344CB8AC3E}">
        <p14:creationId xmlns:p14="http://schemas.microsoft.com/office/powerpoint/2010/main" val="11839073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634875" y="1842844"/>
            <a:ext cx="10957376" cy="4034990"/>
            <a:chOff x="779259" y="875768"/>
            <a:chExt cx="10957376" cy="4034990"/>
          </a:xfrm>
        </p:grpSpPr>
        <p:sp>
          <p:nvSpPr>
            <p:cNvPr id="2" name="矩形 1"/>
            <p:cNvSpPr/>
            <p:nvPr/>
          </p:nvSpPr>
          <p:spPr>
            <a:xfrm>
              <a:off x="1015304" y="2283094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" name="右箭头 2"/>
            <p:cNvSpPr/>
            <p:nvPr/>
          </p:nvSpPr>
          <p:spPr>
            <a:xfrm>
              <a:off x="1801906" y="2571437"/>
              <a:ext cx="6010835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4201293" y="2760947"/>
              <a:ext cx="34327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kern="0" dirty="0" smtClean="0">
                  <a:latin typeface="Arial" charset="0"/>
                  <a:ea typeface="Arial" charset="0"/>
                  <a:cs typeface="Arial" charset="0"/>
                </a:rPr>
                <a:t>ATXN7&amp;THOC7‍</a:t>
              </a:r>
              <a:r>
                <a:rPr lang="en-US" altLang="zh-CN" sz="1400" kern="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(</a:t>
              </a:r>
              <a:r>
                <a:rPr lang="en-US" altLang="zh-CN" sz="1400" b="1" kern="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cg07753241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)</a:t>
              </a:r>
              <a:r>
                <a:rPr lang="zh-CN" altLang="zh-CN" sz="1400" b="1" dirty="0" smtClean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endParaRPr kumimoji="1" lang="en-US" altLang="zh-CN" sz="1400" b="1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ctr"/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5" name="直线连接符 4"/>
            <p:cNvCxnSpPr/>
            <p:nvPr/>
          </p:nvCxnSpPr>
          <p:spPr>
            <a:xfrm flipV="1">
              <a:off x="2799624" y="1560124"/>
              <a:ext cx="0" cy="100584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线连接符 5"/>
            <p:cNvCxnSpPr/>
            <p:nvPr/>
          </p:nvCxnSpPr>
          <p:spPr>
            <a:xfrm flipH="1" flipV="1">
              <a:off x="3849163" y="1988695"/>
              <a:ext cx="10254" cy="56999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线连接符 7"/>
            <p:cNvCxnSpPr/>
            <p:nvPr/>
          </p:nvCxnSpPr>
          <p:spPr>
            <a:xfrm flipV="1">
              <a:off x="5001555" y="1988695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2547890" y="1285576"/>
              <a:ext cx="16841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_1 (</a:t>
              </a:r>
              <a:r>
                <a:rPr kumimoji="1" lang="en-US" altLang="zh-CN" sz="1100" b="1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g07753241) 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3264868" y="1569405"/>
              <a:ext cx="7972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2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6" name="直线连接符 15"/>
            <p:cNvCxnSpPr/>
            <p:nvPr/>
          </p:nvCxnSpPr>
          <p:spPr>
            <a:xfrm flipV="1">
              <a:off x="5639464" y="1673168"/>
              <a:ext cx="0" cy="91440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线连接符 16"/>
            <p:cNvCxnSpPr/>
            <p:nvPr/>
          </p:nvCxnSpPr>
          <p:spPr>
            <a:xfrm flipV="1">
              <a:off x="6257947" y="1297941"/>
              <a:ext cx="9745" cy="128016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线连接符 17"/>
            <p:cNvCxnSpPr/>
            <p:nvPr/>
          </p:nvCxnSpPr>
          <p:spPr>
            <a:xfrm flipV="1">
              <a:off x="6899005" y="1986001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4363097" y="1540663"/>
              <a:ext cx="8220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4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5065166" y="1221913"/>
              <a:ext cx="797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6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699634" y="875768"/>
              <a:ext cx="9087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8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6255212" y="1568946"/>
              <a:ext cx="17579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10   CpG_11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779259" y="3310320"/>
              <a:ext cx="10957376" cy="16004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dist">
                <a:spcAft>
                  <a:spcPts val="0"/>
                </a:spcAft>
              </a:pPr>
              <a:r>
                <a:rPr lang="en-US" altLang="zh-CN" sz="1400" dirty="0" smtClean="0">
                  <a:latin typeface="Arial" charset="0"/>
                </a:rPr>
                <a:t>GCCGCGGCCGCCCCCGGGGAGTACCGGGAGCGCGGGGAGCGCGGGTCCCGCGGCGGCGGCGGCGGCGGCGGCGGCGCGGCGCGGCGCGGCTCAGGCGTCGGAGCAGGCGGCCGCGGGCGCCGCCGCCT</a:t>
              </a:r>
              <a:r>
                <a:rPr lang="en-US" altLang="zh-CN" sz="1400" dirty="0" smtClean="0">
                  <a:highlight>
                    <a:srgbClr val="FFFF00"/>
                  </a:highlight>
                  <a:latin typeface="Arial" charset="0"/>
                </a:rPr>
                <a:t>CCTCCTCCATGGCTGTTTACCCGGCTGCATTGTGGGA</a:t>
              </a:r>
            </a:p>
            <a:p>
              <a:r>
                <a:rPr lang="en-US" altLang="zh-CN" sz="1100" dirty="0" smtClean="0">
                  <a:latin typeface="Arial" charset="0"/>
                </a:rPr>
                <a:t>                               </a:t>
              </a:r>
              <a:r>
                <a:rPr lang="en-US" altLang="zh-CN" sz="1100" b="1" dirty="0" smtClean="0">
                  <a:latin typeface="Arial" charset="0"/>
                </a:rPr>
                <a:t>CpG_1  CpG_2,3                  CpG_4,5                                    CpG_6,7      CpG_8,9    CpG_10,11</a:t>
              </a:r>
              <a:endParaRPr lang="en-US" altLang="zh-CN" sz="1100" b="1" dirty="0">
                <a:highlight>
                  <a:srgbClr val="FFFF00"/>
                </a:highlight>
                <a:latin typeface="Arial" charset="0"/>
              </a:endParaRPr>
            </a:p>
            <a:p>
              <a:pPr algn="dist">
                <a:spcAft>
                  <a:spcPts val="0"/>
                </a:spcAft>
              </a:pPr>
              <a:r>
                <a:rPr lang="en-US" altLang="zh-CN" sz="1400" dirty="0" smtClean="0">
                  <a:highlight>
                    <a:srgbClr val="FFFF00"/>
                  </a:highlight>
                  <a:latin typeface="Arial" charset="0"/>
                </a:rPr>
                <a:t>GTTTGACCT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CAA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CTCAGCTTG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highlight>
                    <a:srgbClr val="00FF00"/>
                  </a:highlight>
                  <a:latin typeface="Arial" charset="0"/>
                </a:rPr>
                <a:t>CCGCCGCCGCGCACGCCATGGGAGCCGTGACTGACG</a:t>
              </a:r>
              <a:r>
                <a:rPr lang="en-US" altLang="zh-CN" sz="1400" dirty="0" smtClean="0">
                  <a:highlight>
                    <a:srgbClr val="FFFF00"/>
                  </a:highlight>
                  <a:latin typeface="Arial" charset="0"/>
                </a:rPr>
                <a:t>GTGAGGCCCCGCTCGCCGCCACACGCGCCCGCTGCACGGCCCGCTGGGCCTCCCCTGAGACCCCTG</a:t>
              </a:r>
              <a:r>
                <a:rPr lang="en-US" altLang="zh-CN" sz="1400" dirty="0" smtClean="0">
                  <a:latin typeface="Arial" charset="0"/>
                </a:rPr>
                <a:t>GCCTCCCGGCCCGCTTCCGGGAACCCCTCGGCCTCCCCGGCCTCTTCGCCAGAGCGCTTCGGCCTTCCCGACCTCTCCCCGGAGCCCCGGGCCTCCCCGGCTGCTTCCCTGAGTCCTTCCTCCTCTCGCCAGAGCCCGAGCGCCCCTCGGAGACCCTCGGCTTTCCCCGTCCGCTCTC</a:t>
              </a:r>
              <a:endParaRPr lang="zh-CN" altLang="zh-CN" sz="1400" dirty="0">
                <a:latin typeface="Times New Roman" charset="0"/>
              </a:endParaRPr>
            </a:p>
          </p:txBody>
        </p:sp>
        <p:cxnSp>
          <p:nvCxnSpPr>
            <p:cNvPr id="29" name="直线连接符 4"/>
            <p:cNvCxnSpPr/>
            <p:nvPr/>
          </p:nvCxnSpPr>
          <p:spPr>
            <a:xfrm flipV="1">
              <a:off x="3902552" y="1989261"/>
              <a:ext cx="0" cy="57607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13"/>
            <p:cNvSpPr txBox="1"/>
            <p:nvPr/>
          </p:nvSpPr>
          <p:spPr>
            <a:xfrm>
              <a:off x="3838388" y="1565389"/>
              <a:ext cx="7972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3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" name="文本框 18"/>
            <p:cNvSpPr txBox="1"/>
            <p:nvPr/>
          </p:nvSpPr>
          <p:spPr>
            <a:xfrm>
              <a:off x="4954588" y="1537115"/>
              <a:ext cx="8220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5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2" name="直线连接符 4"/>
            <p:cNvCxnSpPr/>
            <p:nvPr/>
          </p:nvCxnSpPr>
          <p:spPr>
            <a:xfrm flipV="1">
              <a:off x="4969384" y="1997277"/>
              <a:ext cx="0" cy="57607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线连接符 15"/>
            <p:cNvCxnSpPr/>
            <p:nvPr/>
          </p:nvCxnSpPr>
          <p:spPr>
            <a:xfrm flipV="1">
              <a:off x="5683576" y="1669152"/>
              <a:ext cx="0" cy="91440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19"/>
            <p:cNvSpPr txBox="1"/>
            <p:nvPr/>
          </p:nvSpPr>
          <p:spPr>
            <a:xfrm>
              <a:off x="5638302" y="1219046"/>
              <a:ext cx="797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7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5" name="直线连接符 16"/>
            <p:cNvCxnSpPr/>
            <p:nvPr/>
          </p:nvCxnSpPr>
          <p:spPr>
            <a:xfrm flipV="1">
              <a:off x="6290027" y="1293925"/>
              <a:ext cx="9745" cy="128016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20"/>
            <p:cNvSpPr txBox="1"/>
            <p:nvPr/>
          </p:nvSpPr>
          <p:spPr>
            <a:xfrm>
              <a:off x="6273154" y="883784"/>
              <a:ext cx="9087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100" b="1" dirty="0" smtClean="0">
                  <a:latin typeface="Arial" charset="0"/>
                  <a:ea typeface="Arial" charset="0"/>
                  <a:cs typeface="Arial" charset="0"/>
                </a:rPr>
                <a:t>CpG_9 </a:t>
              </a:r>
              <a:endParaRPr kumimoji="1" lang="zh-CN" alt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7" name="直线连接符 17"/>
            <p:cNvCxnSpPr/>
            <p:nvPr/>
          </p:nvCxnSpPr>
          <p:spPr>
            <a:xfrm flipV="1">
              <a:off x="6931085" y="1981985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线连接符 19"/>
            <p:cNvCxnSpPr/>
            <p:nvPr/>
          </p:nvCxnSpPr>
          <p:spPr>
            <a:xfrm flipH="1" flipV="1">
              <a:off x="4875869" y="1754425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线连接符 19"/>
            <p:cNvCxnSpPr/>
            <p:nvPr/>
          </p:nvCxnSpPr>
          <p:spPr>
            <a:xfrm flipV="1">
              <a:off x="5007091" y="1753238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线连接符 19"/>
            <p:cNvCxnSpPr/>
            <p:nvPr/>
          </p:nvCxnSpPr>
          <p:spPr>
            <a:xfrm flipH="1" flipV="1">
              <a:off x="5553677" y="1445609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线连接符 19"/>
            <p:cNvCxnSpPr/>
            <p:nvPr/>
          </p:nvCxnSpPr>
          <p:spPr>
            <a:xfrm flipV="1">
              <a:off x="5684899" y="1444422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线连接符 19"/>
            <p:cNvCxnSpPr/>
            <p:nvPr/>
          </p:nvCxnSpPr>
          <p:spPr>
            <a:xfrm flipH="1" flipV="1">
              <a:off x="6183357" y="1100697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线连接符 19"/>
            <p:cNvCxnSpPr/>
            <p:nvPr/>
          </p:nvCxnSpPr>
          <p:spPr>
            <a:xfrm flipV="1">
              <a:off x="6302547" y="1099510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线连接符 19"/>
            <p:cNvCxnSpPr/>
            <p:nvPr/>
          </p:nvCxnSpPr>
          <p:spPr>
            <a:xfrm flipH="1" flipV="1">
              <a:off x="6809021" y="1786521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线连接符 19"/>
            <p:cNvCxnSpPr/>
            <p:nvPr/>
          </p:nvCxnSpPr>
          <p:spPr>
            <a:xfrm flipV="1">
              <a:off x="6928211" y="1785334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线连接符 19"/>
            <p:cNvCxnSpPr/>
            <p:nvPr/>
          </p:nvCxnSpPr>
          <p:spPr>
            <a:xfrm flipH="1" flipV="1">
              <a:off x="3764925" y="1810585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线连接符 19"/>
            <p:cNvCxnSpPr/>
            <p:nvPr/>
          </p:nvCxnSpPr>
          <p:spPr>
            <a:xfrm flipV="1">
              <a:off x="3884115" y="1809398"/>
              <a:ext cx="91440" cy="2321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Rectangle 10"/>
          <p:cNvSpPr/>
          <p:nvPr/>
        </p:nvSpPr>
        <p:spPr>
          <a:xfrm>
            <a:off x="870921" y="614071"/>
            <a:ext cx="1051809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TXN7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THOC7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7753241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TXN7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THOC7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7753241) is shown.</a:t>
            </a:r>
          </a:p>
        </p:txBody>
      </p:sp>
    </p:spTree>
    <p:extLst>
      <p:ext uri="{BB962C8B-B14F-4D97-AF65-F5344CB8AC3E}">
        <p14:creationId xmlns:p14="http://schemas.microsoft.com/office/powerpoint/2010/main" val="36238045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77573" y="2327035"/>
            <a:ext cx="10596282" cy="3190551"/>
            <a:chOff x="705381" y="2043225"/>
            <a:chExt cx="10596282" cy="3190551"/>
          </a:xfrm>
        </p:grpSpPr>
        <p:sp>
          <p:nvSpPr>
            <p:cNvPr id="2" name="矩形 1"/>
            <p:cNvSpPr/>
            <p:nvPr/>
          </p:nvSpPr>
          <p:spPr>
            <a:xfrm>
              <a:off x="705381" y="3633338"/>
              <a:ext cx="10596282" cy="16004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GCTCCCGCTCAATGCCCACCTCTCGGCCTCATGGCTGCTTCCCTGCCATTGGTTTCCTACCGGGTGGTTCTTATCCCCATGCCACCTTCCTTGTCTGCTCTGAAGCAGCTGGGTCAGCGCGGAGCTCCCTCGGGCTCTCCTGGGTGTGGAGCCGCAGGTGCAGAGGGACGGCCCAGGCCAACTCTAGCCCCAGGGTCTCTGAGGCCG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</a:rPr>
                <a:t>GGCTGGTGGTGCAGGACACACCCAGGGCGTGGGGTCCCA</a:t>
              </a:r>
            </a:p>
            <a:p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                          </a:t>
              </a:r>
              <a:r>
                <a:rPr lang="en-US" altLang="zh-CN" sz="1100" b="1" dirty="0" err="1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CpG</a:t>
              </a:r>
              <a:endParaRPr lang="en-US" altLang="zh-CN" sz="1100" b="1" dirty="0" smtClean="0">
                <a:solidFill>
                  <a:srgbClr val="000000"/>
                </a:solidFill>
                <a:highlight>
                  <a:srgbClr val="FFFF00"/>
                </a:highlight>
                <a:latin typeface="Arial" charset="0"/>
              </a:endParaRPr>
            </a:p>
            <a:p>
              <a:pPr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</a:rPr>
                <a:t>GGCTTAGGGA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</a:rPr>
                <a:t>T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</a:rPr>
                <a:t>GCAGGGGTGGCTCCCCA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</a:rPr>
                <a:t>ACCACCAGGACCCCGGCAGGATGGGCC</a:t>
              </a: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Times New Roman" charset="0"/>
                </a:rPr>
                <a:t>CTGGCGCTTCTGGAGGGAGATTCACTGTGGTAACCGTCAGCTGCCTTTGTTTATGAGTTGTAAGTCTGCTTCTTGTGAAGTGCGTTTCACACTCAGGGTGTTTGCACTCAGAAAGCGGGTCCTGGTTTTAAAAGCATAAGTTTTGTTCTCTAGAAAATGACATCAACTTTAGACGTCAGATTGCCTGTCCAGCACA</a:t>
              </a:r>
              <a:endParaRPr lang="zh-CN" altLang="zh-CN" sz="1400" dirty="0">
                <a:latin typeface="Times New Roman" charset="0"/>
              </a:endParaRPr>
            </a:p>
          </p:txBody>
        </p:sp>
        <p:sp>
          <p:nvSpPr>
            <p:cNvPr id="3" name="矩形 2"/>
            <p:cNvSpPr/>
            <p:nvPr/>
          </p:nvSpPr>
          <p:spPr>
            <a:xfrm>
              <a:off x="705381" y="2617035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4" name="右箭头 3"/>
            <p:cNvSpPr/>
            <p:nvPr/>
          </p:nvSpPr>
          <p:spPr>
            <a:xfrm>
              <a:off x="4108806" y="2914784"/>
              <a:ext cx="4700337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4284122" y="3134182"/>
              <a:ext cx="3432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AHRR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21161138)</a:t>
              </a:r>
              <a:r>
                <a:rPr lang="zh-CN" altLang="zh-CN" sz="1400" b="1" dirty="0" smtClean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5" name="直线连接符 24"/>
            <p:cNvCxnSpPr/>
            <p:nvPr/>
          </p:nvCxnSpPr>
          <p:spPr>
            <a:xfrm flipV="1">
              <a:off x="6684845" y="2309502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/>
          </p:nvSpPr>
          <p:spPr>
            <a:xfrm>
              <a:off x="5892238" y="2043225"/>
              <a:ext cx="16425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100" b="1" dirty="0" err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</a:t>
              </a:r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 (cg21161138) 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77573" y="947921"/>
            <a:ext cx="105181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HR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21161138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HR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21161138) is shown.</a:t>
            </a:r>
          </a:p>
        </p:txBody>
      </p:sp>
    </p:spTree>
    <p:extLst>
      <p:ext uri="{BB962C8B-B14F-4D97-AF65-F5344CB8AC3E}">
        <p14:creationId xmlns:p14="http://schemas.microsoft.com/office/powerpoint/2010/main" val="14089980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50233" y="2091412"/>
            <a:ext cx="10668000" cy="3207925"/>
            <a:chOff x="850233" y="2664032"/>
            <a:chExt cx="10668000" cy="3207925"/>
          </a:xfrm>
        </p:grpSpPr>
        <p:sp>
          <p:nvSpPr>
            <p:cNvPr id="2" name="矩形 1"/>
            <p:cNvSpPr/>
            <p:nvPr/>
          </p:nvSpPr>
          <p:spPr>
            <a:xfrm>
              <a:off x="850233" y="4271519"/>
              <a:ext cx="10668000" cy="16004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TCCCTCCCACCTGTGGAACTGAGTGAGCAGCAGCAGCAATGTCCCACCTTTCCTGCTCTCCTCAAGCTCTCCTCAAGCTCTGTCTCTTCTGGCAGGCACAGGAGAGTGGCCTGAAGGCTGGCAGGAGGTTGCCGCCCCTCCAACCTGGAATTCCTGGCAGCAGCAGC</a:t>
              </a:r>
            </a:p>
            <a:p>
              <a:r>
                <a:rPr lang="en-US" altLang="zh-CN" sz="1100" b="1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                                                                                                                                                                                                                                   </a:t>
              </a:r>
              <a:r>
                <a:rPr lang="en-US" altLang="zh-CN" sz="1100" b="1" dirty="0" err="1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CpG</a:t>
              </a:r>
              <a:endParaRPr lang="en-US" altLang="zh-CN" sz="11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>
                <a:spcAft>
                  <a:spcPts val="0"/>
                </a:spcAft>
              </a:pP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GGCTAGGCCTTCCTCGGAGGCCCGACCCCCTCCTCCT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Arial" charset="0"/>
                  <a:cs typeface="Arial" charset="0"/>
                </a:rPr>
                <a:t>TCTTGGTTCAGCTCAGGACTCTGAGGGTTGCT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G</a:t>
              </a:r>
              <a:r>
                <a:rPr lang="en-US" altLang="zh-CN" sz="1400" dirty="0" smtClean="0">
                  <a:solidFill>
                    <a:srgbClr val="FF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CG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00FF00"/>
                  </a:highlight>
                  <a:latin typeface="Arial" charset="0"/>
                  <a:ea typeface="Arial" charset="0"/>
                  <a:cs typeface="Arial" charset="0"/>
                </a:rPr>
                <a:t>TGGAGGCAGTGCATGCCCTGGGCA</a:t>
              </a:r>
              <a:r>
                <a:rPr lang="en-US" altLang="zh-CN" sz="140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Arial" charset="0"/>
                  <a:ea typeface="Arial" charset="0"/>
                  <a:cs typeface="Arial" charset="0"/>
                </a:rPr>
                <a:t>CAGTGCCC</a:t>
              </a:r>
              <a:r>
                <a:rPr lang="en-US" altLang="zh-CN" sz="1400" dirty="0" smtClean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AGTTCCTGCCCACCCAGGAAGTAGACTTCGGGTGGAGGCAGTAGGCTGGGGAGGGGCGGGGAGCTTGGACAGGAAGGAGCCTTGCTCATTGCCCGGCAGACACAAGACTGGGCCCTCATAAACTCAGACAGCCCGGCATGTCACCTGTTGTACCTGCCCTTTCAGCTCTGTGACCCGGGACAAGTCACCCTCTCCCTTTGAGTTGCCGCAAGAGGTACAGTCACACTGC</a:t>
              </a:r>
              <a:endParaRPr lang="zh-CN" altLang="zh-CN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" name="矩形 2"/>
            <p:cNvSpPr/>
            <p:nvPr/>
          </p:nvSpPr>
          <p:spPr>
            <a:xfrm>
              <a:off x="850233" y="3279280"/>
              <a:ext cx="10518099" cy="4572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4" name="右箭头 3"/>
            <p:cNvSpPr/>
            <p:nvPr/>
          </p:nvSpPr>
          <p:spPr>
            <a:xfrm>
              <a:off x="2607921" y="3562037"/>
              <a:ext cx="4700337" cy="2286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4468979" y="3772848"/>
              <a:ext cx="3432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SERPINA1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kumimoji="1"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mplicon  (</a:t>
              </a:r>
              <a:r>
                <a:rPr lang="en-US" altLang="zh-CN" sz="1400" b="1" dirty="0" smtClean="0">
                  <a:latin typeface="Arial" charset="0"/>
                  <a:ea typeface="Arial" charset="0"/>
                  <a:cs typeface="Arial" charset="0"/>
                </a:rPr>
                <a:t>cg02181506)</a:t>
              </a:r>
              <a:r>
                <a:rPr lang="zh-CN" altLang="zh-CN" sz="1400" b="1" dirty="0" smtClean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endParaRPr kumimoji="1"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" name="直线连接符 5"/>
            <p:cNvCxnSpPr/>
            <p:nvPr/>
          </p:nvCxnSpPr>
          <p:spPr>
            <a:xfrm flipV="1">
              <a:off x="4262960" y="2958801"/>
              <a:ext cx="0" cy="57744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/>
            <p:cNvSpPr txBox="1"/>
            <p:nvPr/>
          </p:nvSpPr>
          <p:spPr>
            <a:xfrm>
              <a:off x="3504622" y="2664032"/>
              <a:ext cx="15297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100" b="1" dirty="0" err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pG</a:t>
              </a:r>
              <a:r>
                <a:rPr kumimoji="1" lang="en-US" altLang="zh-CN" sz="11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 (cg02181506) </a:t>
              </a:r>
              <a:endParaRPr kumimoji="1" lang="zh-CN" altLang="en-US" sz="11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18188" y="79847"/>
            <a:ext cx="280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850232" y="823944"/>
            <a:ext cx="105181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arg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quence for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ERPINA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2181506). The target sequence (marked yellow highlights) and its cover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ites (red letters) analyzed by pyrosequencing assay (marked green highlights)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ERPINA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cg02181506) is shown.</a:t>
            </a:r>
          </a:p>
        </p:txBody>
      </p:sp>
    </p:spTree>
    <p:extLst>
      <p:ext uri="{BB962C8B-B14F-4D97-AF65-F5344CB8AC3E}">
        <p14:creationId xmlns:p14="http://schemas.microsoft.com/office/powerpoint/2010/main" val="1114244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4</TotalTime>
  <Words>1070</Words>
  <Application>Microsoft Office PowerPoint</Application>
  <PresentationFormat>Widescreen</PresentationFormat>
  <Paragraphs>110</Paragraphs>
  <Slides>1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宋体</vt:lpstr>
      <vt:lpstr>Arial</vt:lpstr>
      <vt:lpstr>Calibri</vt:lpstr>
      <vt:lpstr>Calibri Light</vt:lpstr>
      <vt:lpstr>Cambria</vt:lpstr>
      <vt:lpstr>Courier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Sundar, Isaac K</cp:lastModifiedBy>
  <cp:revision>102</cp:revision>
  <dcterms:created xsi:type="dcterms:W3CDTF">2016-11-13T23:17:05Z</dcterms:created>
  <dcterms:modified xsi:type="dcterms:W3CDTF">2017-04-03T18:47:22Z</dcterms:modified>
</cp:coreProperties>
</file>